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66" y="3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11454D5-D638-33A1-6BD9-BAC0F82A03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8E412A4-A0C0-09D6-BE7A-03DC3A6997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C09E07-DD6A-2D3F-E198-C9C1DAE96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EC46819-0E78-3E8A-EB8B-276D94990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B7276B0-92C4-A615-039E-2AD499663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474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A294926-62B9-6884-AF9B-96BED04885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E645AE7-4AAF-4B88-F9A8-8A0EA297A6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D0E7253-6718-3373-6D60-C4CF82D5E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3AE67A-DE64-C090-9B8E-65827A063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81E2C3-C9A3-C3EA-96A2-839704AD9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367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76B77AB-AF46-5A99-D0ED-72555F2D9C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2CD72E7-908D-D9BF-06CF-7ABCA4368A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BCB721A-3287-8292-19B4-7E700F629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32A0FD-6512-363B-0732-A835F9CCF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91F1FB-729E-D1EF-9283-B56B10DB2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0557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E211E0E-6DCD-79D0-9AF5-B41294B8C3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A2754F-741E-DA73-D070-02F0997FC2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1BAC7A5-73D6-D105-4C0A-94712C7BC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027131-AEB2-D9EB-2493-302982246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5A934EE-76E5-CCC5-D294-774576169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474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D8C551-1365-3138-9D92-9D74B7C31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DEA8FD-63F9-42FC-87C8-B050F55D71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5DBD35-D3CD-AF80-8BBB-2B2857FA1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0FE7E8-3ACD-D650-D837-35F396E24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5B8CA8-B025-6AB7-47AA-FA5094DEF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1145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058A74-D2A2-432C-BE04-FD5AB9D39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5580122-6FF3-E535-BECB-67CE0E4473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6C00BCC-43CA-FB63-6113-73135A4B04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2BF0BD-D429-6060-9EF4-D74324B24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F93075E-AEC5-C9AA-0D01-0BE72B83C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7220058-DF2E-2433-E297-FF6170A09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3938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0D7D26-72BE-AE5B-F666-F13A273F29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B6534E9-D1ED-ED85-3C26-15ED12A37B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641B30B-F1C1-4F9E-567E-0B55C84A3B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75E6CB6-79FE-0E58-FAC3-61F1F1D547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7D9E487-C57B-DA1E-0ADB-AB27F5C53E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B0C73B7-20B6-B589-9B48-E16E4F72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698B44E-7FF6-02F1-94CC-C52A17DA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2C4A90A-CBA5-7420-8F1E-F92EC26DB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0151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F45407-5598-F5B6-9691-D9F49A2EF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1484C11-F14F-92B5-56C8-D1B974545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856933D-1D47-8E25-46A7-5BB7FA404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8C12692-3754-3F77-1939-5CF9C3936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3276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326C44-801B-0867-A24F-F018BF617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F784B04-452D-1064-E198-3A59640E2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2202467-016D-67C2-C929-D30C9F7FB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4735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596E56-5056-B5E9-4575-C803061F0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3E4FA61-7B67-3B25-3466-CCBAA4937D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0C64D24-6A4D-174F-9F9B-62E3767A80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872630C-5C30-0C0D-A933-44A729F74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D352EC6-0606-8F91-6B41-2236A011C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56E75A4-B05E-13EB-BFE2-4C107F876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606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D42CF40-1946-A210-AF36-DAB8DEE2A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44D2178-6676-10C1-D39B-65B4A2FD35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1444CC6-CBD3-7D67-84CF-4A61D11193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BA0FC2E-827F-E531-413C-BE72F8AFD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EB9E0AE-5EE7-1067-58C7-948F743F3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17F292F-9E13-BB4B-8461-386A0C59D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6756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A7CF0F9-DCC0-9074-32D6-9E8A7304B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955845-706B-0441-A851-190C34A1CB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8B16F26-8E37-BB84-2BB6-14E5C1BB5D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725E2-0E7A-4E47-B78A-E22C11D585D2}" type="datetimeFigureOut">
              <a:rPr lang="ko-KR" altLang="en-US" smtClean="0"/>
              <a:t>2023-05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E42D2A8-DE02-9E40-93E6-ED82F2D238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B811B3-5DBA-F8F9-33D2-2643940328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35942-2099-4789-8757-D0B177B4DC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115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856FBA1B-6593-A401-82B4-A0FBD54E2EC3}"/>
              </a:ext>
            </a:extLst>
          </p:cNvPr>
          <p:cNvSpPr/>
          <p:nvPr/>
        </p:nvSpPr>
        <p:spPr>
          <a:xfrm>
            <a:off x="295947" y="5540375"/>
            <a:ext cx="6821098" cy="5612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</a:t>
            </a:r>
            <a:r>
              <a:rPr lang="en-US" altLang="ko-KR" dirty="0">
                <a:solidFill>
                  <a:srgbClr val="000000"/>
                </a:solidFill>
                <a:latin typeface="Times" panose="02020603050405020304" pitchFamily="18" charset="0"/>
                <a:cs typeface="맑은 고딕" panose="020B0503020000020004" pitchFamily="50" charset="-127"/>
              </a:rPr>
              <a:t>Figure S1. Gait parameters extracted from smart insole</a:t>
            </a:r>
            <a:endParaRPr lang="ko-KR" altLang="ko-KR" sz="1200" dirty="0">
              <a:solidFill>
                <a:srgbClr val="000000"/>
              </a:solidFill>
              <a:latin typeface="맑은 고딕" panose="020B0503020000020004" pitchFamily="50" charset="-127"/>
              <a:cs typeface="맑은 고딕" panose="020B0503020000020004" pitchFamily="50" charset="-127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7F3E01CD-B13D-2BF1-533A-A2E50EE169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614" y="601629"/>
            <a:ext cx="7865392" cy="5078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2092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직사각형 10"/>
          <p:cNvSpPr/>
          <p:nvPr/>
        </p:nvSpPr>
        <p:spPr>
          <a:xfrm>
            <a:off x="644434" y="5564226"/>
            <a:ext cx="7013458" cy="5612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</a:t>
            </a:r>
            <a:r>
              <a:rPr lang="en-US" altLang="ko-KR" dirty="0">
                <a:solidFill>
                  <a:srgbClr val="000000"/>
                </a:solidFill>
                <a:latin typeface="Times" panose="02020603050405020304" pitchFamily="18" charset="0"/>
                <a:cs typeface="맑은 고딕" panose="020B0503020000020004" pitchFamily="50" charset="-127"/>
              </a:rPr>
              <a:t>Figure S2. Gait variables extracted from pose estimation</a:t>
            </a:r>
            <a:endParaRPr lang="ko-KR" altLang="ko-KR" sz="1200" dirty="0">
              <a:solidFill>
                <a:srgbClr val="000000"/>
              </a:solidFill>
              <a:latin typeface="맑은 고딕" panose="020B0503020000020004" pitchFamily="50" charset="-127"/>
              <a:cs typeface="맑은 고딕" panose="020B0503020000020004" pitchFamily="50" charset="-127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A556DD7-DA04-5D4D-9EC6-0D7938F637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4434" y="536883"/>
            <a:ext cx="6277851" cy="4686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4780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20</Words>
  <Application>Microsoft Office PowerPoint</Application>
  <PresentationFormat>와이드스크린</PresentationFormat>
  <Paragraphs>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Times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ONSU KIM</dc:creator>
  <cp:lastModifiedBy>HYEONSU KIM</cp:lastModifiedBy>
  <cp:revision>6</cp:revision>
  <dcterms:created xsi:type="dcterms:W3CDTF">2023-05-08T09:21:09Z</dcterms:created>
  <dcterms:modified xsi:type="dcterms:W3CDTF">2023-05-30T07:37:47Z</dcterms:modified>
</cp:coreProperties>
</file>